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42"/>
    <p:restoredTop sz="94648"/>
  </p:normalViewPr>
  <p:slideViewPr>
    <p:cSldViewPr>
      <p:cViewPr>
        <p:scale>
          <a:sx n="95" d="100"/>
          <a:sy n="95" d="100"/>
        </p:scale>
        <p:origin x="1696" y="-2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539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4082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9835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9312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4970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1225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6140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306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85685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3255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3334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AB353-CA2B-4FF5-BFA6-A62054481D3F}" type="datetimeFigureOut">
              <a:rPr lang="zh-CN" altLang="en-US" smtClean="0"/>
              <a:t>2024/9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0F754-1064-4876-A4F1-21313BE3C8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80742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7" Type="http://schemas.openxmlformats.org/officeDocument/2006/relationships/image" Target="../media/image17.tif"/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"/><Relationship Id="rId5" Type="http://schemas.openxmlformats.org/officeDocument/2006/relationships/image" Target="../media/image15.tif"/><Relationship Id="rId4" Type="http://schemas.openxmlformats.org/officeDocument/2006/relationships/image" Target="../media/image1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Documents\WeChat Files\kk_fox\FileStorage\File\2023-03\WB-original image\Figure 1\1-C\DAO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849" r="-7849"/>
          <a:stretch/>
        </p:blipFill>
        <p:spPr bwMode="auto">
          <a:xfrm>
            <a:off x="2276872" y="1423828"/>
            <a:ext cx="1656184" cy="9391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D:\Documents\WeChat Files\kk_fox\FileStorage\File\2023-03\WB-original image\Figure 1\1-C\β- actin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92" t="40178" r="35094" b="33125"/>
          <a:stretch/>
        </p:blipFill>
        <p:spPr bwMode="auto">
          <a:xfrm>
            <a:off x="2276872" y="2432720"/>
            <a:ext cx="1656184" cy="8813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矩形 3"/>
          <p:cNvSpPr/>
          <p:nvPr/>
        </p:nvSpPr>
        <p:spPr>
          <a:xfrm>
            <a:off x="1729026" y="1754891"/>
            <a:ext cx="5180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A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1547124" y="2802515"/>
            <a:ext cx="6912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94744" y="1239162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1-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8" name="Picture 4" descr="D:\Documents\WeChat Files\kk_fox\FileStorage\File\2023-03\WB-original image\Figure 1\1-F\Dao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5" t="38081" r="-1528" b="38508"/>
          <a:stretch/>
        </p:blipFill>
        <p:spPr bwMode="auto">
          <a:xfrm>
            <a:off x="1618122" y="3656856"/>
            <a:ext cx="3133362" cy="10272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D:\Documents\WeChat Files\kk_fox\FileStorage\File\2023-03\WB-original image\Figure 1\1-F\β-actin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990" b="42612"/>
          <a:stretch/>
        </p:blipFill>
        <p:spPr bwMode="auto">
          <a:xfrm>
            <a:off x="1791795" y="4711808"/>
            <a:ext cx="3224697" cy="10804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矩形 6"/>
          <p:cNvSpPr/>
          <p:nvPr/>
        </p:nvSpPr>
        <p:spPr>
          <a:xfrm>
            <a:off x="1120576" y="3824708"/>
            <a:ext cx="4651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a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1114832" y="4975043"/>
            <a:ext cx="6479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618122" y="776536"/>
            <a:ext cx="3591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Uncropped  Western Blots Band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2021632" y="295290"/>
            <a:ext cx="24801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l Materia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188640" y="3472190"/>
            <a:ext cx="7312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1-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0" name="Picture 6" descr="D:\Documents\WeChat Files\kk_fox\FileStorage\File\2023-03\WB-original image\Figure 2\2-C\N-Cadherin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321" b="39385"/>
          <a:stretch/>
        </p:blipFill>
        <p:spPr bwMode="auto">
          <a:xfrm>
            <a:off x="1885677" y="6163056"/>
            <a:ext cx="3014663" cy="10058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D:\Documents\WeChat Files\kk_fox\FileStorage\File\2023-03\WB-original image\Figure 2\2-C\β-actin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6" t="37749" r="-2535" b="36043"/>
          <a:stretch/>
        </p:blipFill>
        <p:spPr bwMode="auto">
          <a:xfrm>
            <a:off x="1875013" y="7041232"/>
            <a:ext cx="2974848" cy="1085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矩形 11"/>
          <p:cNvSpPr/>
          <p:nvPr/>
        </p:nvSpPr>
        <p:spPr>
          <a:xfrm>
            <a:off x="805608" y="6527476"/>
            <a:ext cx="9669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-Cadher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1164310" y="7183148"/>
            <a:ext cx="6479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188640" y="5978390"/>
            <a:ext cx="7312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2-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90713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5" t="21454" r="5716" b="13241"/>
          <a:stretch/>
        </p:blipFill>
        <p:spPr>
          <a:xfrm>
            <a:off x="2060848" y="1208584"/>
            <a:ext cx="3945699" cy="704469"/>
          </a:xfrm>
          <a:prstGeom prst="rect">
            <a:avLst/>
          </a:prstGeom>
        </p:spPr>
      </p:pic>
      <p:sp>
        <p:nvSpPr>
          <p:cNvPr id="12" name="矩形 11"/>
          <p:cNvSpPr/>
          <p:nvPr/>
        </p:nvSpPr>
        <p:spPr>
          <a:xfrm>
            <a:off x="476672" y="1136576"/>
            <a:ext cx="72327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5-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1124744" y="1496616"/>
            <a:ext cx="9685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53(S20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348880" y="1136576"/>
            <a:ext cx="1800200" cy="792088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476672" y="5673080"/>
            <a:ext cx="72327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5-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5" t="21454" r="5716" b="13241"/>
          <a:stretch/>
        </p:blipFill>
        <p:spPr>
          <a:xfrm>
            <a:off x="1916832" y="5745088"/>
            <a:ext cx="3945699" cy="704469"/>
          </a:xfrm>
          <a:prstGeom prst="rect">
            <a:avLst/>
          </a:prstGeom>
        </p:spPr>
      </p:pic>
      <p:sp>
        <p:nvSpPr>
          <p:cNvPr id="17" name="矩形 16"/>
          <p:cNvSpPr/>
          <p:nvPr/>
        </p:nvSpPr>
        <p:spPr>
          <a:xfrm>
            <a:off x="4077072" y="5673080"/>
            <a:ext cx="1800200" cy="792088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1052736" y="6033120"/>
            <a:ext cx="9685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53(S20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2" t="6047" r="5496" b="7510"/>
          <a:stretch/>
        </p:blipFill>
        <p:spPr>
          <a:xfrm>
            <a:off x="2132856" y="2072680"/>
            <a:ext cx="3744416" cy="795827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1196752" y="2288704"/>
            <a:ext cx="4571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2348880" y="2072680"/>
            <a:ext cx="1800200" cy="792088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2" t="6047" r="5496" b="7510"/>
          <a:stretch/>
        </p:blipFill>
        <p:spPr>
          <a:xfrm>
            <a:off x="1988840" y="6537176"/>
            <a:ext cx="3816424" cy="795827"/>
          </a:xfrm>
          <a:prstGeom prst="rect">
            <a:avLst/>
          </a:prstGeom>
        </p:spPr>
      </p:pic>
      <p:sp>
        <p:nvSpPr>
          <p:cNvPr id="26" name="矩形 25"/>
          <p:cNvSpPr/>
          <p:nvPr/>
        </p:nvSpPr>
        <p:spPr>
          <a:xfrm>
            <a:off x="1171624" y="6753200"/>
            <a:ext cx="4571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/>
          <p:cNvSpPr/>
          <p:nvPr/>
        </p:nvSpPr>
        <p:spPr>
          <a:xfrm>
            <a:off x="4149080" y="6537176"/>
            <a:ext cx="1728192" cy="792088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14" t="16160" r="10706" b="14760"/>
          <a:stretch/>
        </p:blipFill>
        <p:spPr>
          <a:xfrm>
            <a:off x="1844824" y="7545288"/>
            <a:ext cx="4179531" cy="738276"/>
          </a:xfrm>
          <a:prstGeom prst="rect">
            <a:avLst/>
          </a:prstGeom>
        </p:spPr>
      </p:pic>
      <p:sp>
        <p:nvSpPr>
          <p:cNvPr id="24" name="矩形 23"/>
          <p:cNvSpPr/>
          <p:nvPr/>
        </p:nvSpPr>
        <p:spPr>
          <a:xfrm>
            <a:off x="3933056" y="7545288"/>
            <a:ext cx="1800200" cy="792088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1171624" y="7761312"/>
            <a:ext cx="4571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1196752" y="3307849"/>
            <a:ext cx="4571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93" t="19050" r="13009" b="13626"/>
          <a:stretch/>
        </p:blipFill>
        <p:spPr>
          <a:xfrm>
            <a:off x="2132856" y="2936776"/>
            <a:ext cx="2823815" cy="864096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11" t="22086" r="15446" b="27883"/>
          <a:stretch/>
        </p:blipFill>
        <p:spPr>
          <a:xfrm>
            <a:off x="2060848" y="4088904"/>
            <a:ext cx="3751512" cy="513348"/>
          </a:xfrm>
          <a:prstGeom prst="rect">
            <a:avLst/>
          </a:prstGeom>
        </p:spPr>
      </p:pic>
      <p:sp>
        <p:nvSpPr>
          <p:cNvPr id="33" name="矩形 32"/>
          <p:cNvSpPr/>
          <p:nvPr/>
        </p:nvSpPr>
        <p:spPr>
          <a:xfrm>
            <a:off x="1196752" y="4232920"/>
            <a:ext cx="7312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1988840" y="3944888"/>
            <a:ext cx="1800200" cy="792088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5" name="图片 3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11" t="22086" r="15446" b="27883"/>
          <a:stretch/>
        </p:blipFill>
        <p:spPr>
          <a:xfrm>
            <a:off x="2060848" y="8553400"/>
            <a:ext cx="3751512" cy="513348"/>
          </a:xfrm>
          <a:prstGeom prst="rect">
            <a:avLst/>
          </a:prstGeom>
        </p:spPr>
      </p:pic>
      <p:sp>
        <p:nvSpPr>
          <p:cNvPr id="36" name="矩形 35"/>
          <p:cNvSpPr/>
          <p:nvPr/>
        </p:nvSpPr>
        <p:spPr>
          <a:xfrm>
            <a:off x="1196752" y="8697416"/>
            <a:ext cx="7312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3933056" y="8409384"/>
            <a:ext cx="1584176" cy="792088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68743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76672" y="0"/>
            <a:ext cx="71526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7-F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1052736" y="3656856"/>
            <a:ext cx="9509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53(S20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1196752" y="2288704"/>
            <a:ext cx="4395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1196752" y="4592960"/>
            <a:ext cx="6415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1196752" y="5673080"/>
            <a:ext cx="6912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1196752" y="416496"/>
            <a:ext cx="4651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a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24" t="25521" r="12908" b="46601"/>
          <a:stretch/>
        </p:blipFill>
        <p:spPr>
          <a:xfrm>
            <a:off x="1988840" y="0"/>
            <a:ext cx="3684337" cy="1085515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4" t="35410" r="3719" b="39871"/>
          <a:stretch/>
        </p:blipFill>
        <p:spPr>
          <a:xfrm>
            <a:off x="1916832" y="1136576"/>
            <a:ext cx="3812625" cy="671500"/>
          </a:xfrm>
          <a:prstGeom prst="rect">
            <a:avLst/>
          </a:prstGeom>
        </p:spPr>
      </p:pic>
      <p:sp>
        <p:nvSpPr>
          <p:cNvPr id="14" name="矩形 13"/>
          <p:cNvSpPr/>
          <p:nvPr/>
        </p:nvSpPr>
        <p:spPr>
          <a:xfrm>
            <a:off x="1196752" y="1424608"/>
            <a:ext cx="6912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3" t="27718" r="26060" b="43855"/>
          <a:stretch/>
        </p:blipFill>
        <p:spPr>
          <a:xfrm>
            <a:off x="1988840" y="1928664"/>
            <a:ext cx="3625517" cy="1106907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78" t="24285" r="22727" b="48661"/>
          <a:stretch/>
        </p:blipFill>
        <p:spPr>
          <a:xfrm>
            <a:off x="2060848" y="3224808"/>
            <a:ext cx="3672408" cy="1053433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67" t="37606" r="14079" b="37400"/>
          <a:stretch/>
        </p:blipFill>
        <p:spPr>
          <a:xfrm>
            <a:off x="2060848" y="4304928"/>
            <a:ext cx="3672408" cy="973221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06" t="33211" r="32636" b="52644"/>
          <a:stretch/>
        </p:blipFill>
        <p:spPr>
          <a:xfrm>
            <a:off x="1988840" y="5457056"/>
            <a:ext cx="3456384" cy="648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318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58</Words>
  <Application>Microsoft Macintosh PowerPoint</Application>
  <PresentationFormat>A4 纸张(210x297 毫米)</PresentationFormat>
  <Paragraphs>2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b21cn</dc:creator>
  <cp:lastModifiedBy>Microsoft Office User</cp:lastModifiedBy>
  <cp:revision>21</cp:revision>
  <cp:lastPrinted>2024-05-07T07:12:42Z</cp:lastPrinted>
  <dcterms:created xsi:type="dcterms:W3CDTF">2023-03-09T16:04:46Z</dcterms:created>
  <dcterms:modified xsi:type="dcterms:W3CDTF">2024-09-04T10:44:52Z</dcterms:modified>
</cp:coreProperties>
</file>